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44" r:id="rId1"/>
  </p:sldMasterIdLst>
  <p:sldIdLst>
    <p:sldId id="256" r:id="rId2"/>
  </p:sldIdLst>
  <p:sldSz cx="10458450" cy="5584825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3292" autoAdjust="0"/>
    <p:restoredTop sz="94676" autoAdjust="0"/>
  </p:normalViewPr>
  <p:slideViewPr>
    <p:cSldViewPr snapToGrid="0">
      <p:cViewPr varScale="1">
        <p:scale>
          <a:sx n="130" d="100"/>
          <a:sy n="130" d="100"/>
        </p:scale>
        <p:origin x="1242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07306" y="913999"/>
            <a:ext cx="7843838" cy="1944346"/>
          </a:xfrm>
        </p:spPr>
        <p:txBody>
          <a:bodyPr anchor="b"/>
          <a:lstStyle>
            <a:lvl1pPr algn="ctr">
              <a:defRPr sz="488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07306" y="2933326"/>
            <a:ext cx="7843838" cy="1348373"/>
          </a:xfrm>
        </p:spPr>
        <p:txBody>
          <a:bodyPr/>
          <a:lstStyle>
            <a:lvl1pPr marL="0" indent="0" algn="ctr">
              <a:buNone/>
              <a:defRPr sz="1955"/>
            </a:lvl1pPr>
            <a:lvl2pPr marL="372344" indent="0" algn="ctr">
              <a:buNone/>
              <a:defRPr sz="1629"/>
            </a:lvl2pPr>
            <a:lvl3pPr marL="744687" indent="0" algn="ctr">
              <a:buNone/>
              <a:defRPr sz="1466"/>
            </a:lvl3pPr>
            <a:lvl4pPr marL="1117031" indent="0" algn="ctr">
              <a:buNone/>
              <a:defRPr sz="1303"/>
            </a:lvl4pPr>
            <a:lvl5pPr marL="1489375" indent="0" algn="ctr">
              <a:buNone/>
              <a:defRPr sz="1303"/>
            </a:lvl5pPr>
            <a:lvl6pPr marL="1861718" indent="0" algn="ctr">
              <a:buNone/>
              <a:defRPr sz="1303"/>
            </a:lvl6pPr>
            <a:lvl7pPr marL="2234062" indent="0" algn="ctr">
              <a:buNone/>
              <a:defRPr sz="1303"/>
            </a:lvl7pPr>
            <a:lvl8pPr marL="2606406" indent="0" algn="ctr">
              <a:buNone/>
              <a:defRPr sz="1303"/>
            </a:lvl8pPr>
            <a:lvl9pPr marL="2978749" indent="0" algn="ctr">
              <a:buNone/>
              <a:defRPr sz="130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72955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93553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484328" y="297340"/>
            <a:ext cx="2255103" cy="473288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19019" y="297340"/>
            <a:ext cx="6634579" cy="473288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45840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90410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3571" y="1392329"/>
            <a:ext cx="9020413" cy="2323132"/>
          </a:xfrm>
        </p:spPr>
        <p:txBody>
          <a:bodyPr anchor="b"/>
          <a:lstStyle>
            <a:lvl1pPr>
              <a:defRPr sz="488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13571" y="3737438"/>
            <a:ext cx="9020413" cy="1221680"/>
          </a:xfrm>
        </p:spPr>
        <p:txBody>
          <a:bodyPr/>
          <a:lstStyle>
            <a:lvl1pPr marL="0" indent="0">
              <a:buNone/>
              <a:defRPr sz="1955">
                <a:solidFill>
                  <a:schemeClr val="tx1">
                    <a:tint val="75000"/>
                  </a:schemeClr>
                </a:solidFill>
              </a:defRPr>
            </a:lvl1pPr>
            <a:lvl2pPr marL="372344" indent="0">
              <a:buNone/>
              <a:defRPr sz="1629">
                <a:solidFill>
                  <a:schemeClr val="tx1">
                    <a:tint val="75000"/>
                  </a:schemeClr>
                </a:solidFill>
              </a:defRPr>
            </a:lvl2pPr>
            <a:lvl3pPr marL="744687" indent="0">
              <a:buNone/>
              <a:defRPr sz="1466">
                <a:solidFill>
                  <a:schemeClr val="tx1">
                    <a:tint val="75000"/>
                  </a:schemeClr>
                </a:solidFill>
              </a:defRPr>
            </a:lvl3pPr>
            <a:lvl4pPr marL="1117031" indent="0">
              <a:buNone/>
              <a:defRPr sz="1303">
                <a:solidFill>
                  <a:schemeClr val="tx1">
                    <a:tint val="75000"/>
                  </a:schemeClr>
                </a:solidFill>
              </a:defRPr>
            </a:lvl4pPr>
            <a:lvl5pPr marL="1489375" indent="0">
              <a:buNone/>
              <a:defRPr sz="1303">
                <a:solidFill>
                  <a:schemeClr val="tx1">
                    <a:tint val="75000"/>
                  </a:schemeClr>
                </a:solidFill>
              </a:defRPr>
            </a:lvl5pPr>
            <a:lvl6pPr marL="1861718" indent="0">
              <a:buNone/>
              <a:defRPr sz="1303">
                <a:solidFill>
                  <a:schemeClr val="tx1">
                    <a:tint val="75000"/>
                  </a:schemeClr>
                </a:solidFill>
              </a:defRPr>
            </a:lvl6pPr>
            <a:lvl7pPr marL="2234062" indent="0">
              <a:buNone/>
              <a:defRPr sz="1303">
                <a:solidFill>
                  <a:schemeClr val="tx1">
                    <a:tint val="75000"/>
                  </a:schemeClr>
                </a:solidFill>
              </a:defRPr>
            </a:lvl7pPr>
            <a:lvl8pPr marL="2606406" indent="0">
              <a:buNone/>
              <a:defRPr sz="1303">
                <a:solidFill>
                  <a:schemeClr val="tx1">
                    <a:tint val="75000"/>
                  </a:schemeClr>
                </a:solidFill>
              </a:defRPr>
            </a:lvl8pPr>
            <a:lvl9pPr marL="2978749" indent="0">
              <a:buNone/>
              <a:defRPr sz="130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46317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19019" y="1486701"/>
            <a:ext cx="4444841" cy="354352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94590" y="1486701"/>
            <a:ext cx="4444841" cy="354352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42836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0381" y="297340"/>
            <a:ext cx="9020413" cy="10794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0381" y="1369058"/>
            <a:ext cx="4424414" cy="670954"/>
          </a:xfrm>
        </p:spPr>
        <p:txBody>
          <a:bodyPr anchor="b"/>
          <a:lstStyle>
            <a:lvl1pPr marL="0" indent="0">
              <a:buNone/>
              <a:defRPr sz="1955" b="1"/>
            </a:lvl1pPr>
            <a:lvl2pPr marL="372344" indent="0">
              <a:buNone/>
              <a:defRPr sz="1629" b="1"/>
            </a:lvl2pPr>
            <a:lvl3pPr marL="744687" indent="0">
              <a:buNone/>
              <a:defRPr sz="1466" b="1"/>
            </a:lvl3pPr>
            <a:lvl4pPr marL="1117031" indent="0">
              <a:buNone/>
              <a:defRPr sz="1303" b="1"/>
            </a:lvl4pPr>
            <a:lvl5pPr marL="1489375" indent="0">
              <a:buNone/>
              <a:defRPr sz="1303" b="1"/>
            </a:lvl5pPr>
            <a:lvl6pPr marL="1861718" indent="0">
              <a:buNone/>
              <a:defRPr sz="1303" b="1"/>
            </a:lvl6pPr>
            <a:lvl7pPr marL="2234062" indent="0">
              <a:buNone/>
              <a:defRPr sz="1303" b="1"/>
            </a:lvl7pPr>
            <a:lvl8pPr marL="2606406" indent="0">
              <a:buNone/>
              <a:defRPr sz="1303" b="1"/>
            </a:lvl8pPr>
            <a:lvl9pPr marL="2978749" indent="0">
              <a:buNone/>
              <a:defRPr sz="130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20381" y="2040012"/>
            <a:ext cx="4424414" cy="300055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294591" y="1369058"/>
            <a:ext cx="4446203" cy="670954"/>
          </a:xfrm>
        </p:spPr>
        <p:txBody>
          <a:bodyPr anchor="b"/>
          <a:lstStyle>
            <a:lvl1pPr marL="0" indent="0">
              <a:buNone/>
              <a:defRPr sz="1955" b="1"/>
            </a:lvl1pPr>
            <a:lvl2pPr marL="372344" indent="0">
              <a:buNone/>
              <a:defRPr sz="1629" b="1"/>
            </a:lvl2pPr>
            <a:lvl3pPr marL="744687" indent="0">
              <a:buNone/>
              <a:defRPr sz="1466" b="1"/>
            </a:lvl3pPr>
            <a:lvl4pPr marL="1117031" indent="0">
              <a:buNone/>
              <a:defRPr sz="1303" b="1"/>
            </a:lvl4pPr>
            <a:lvl5pPr marL="1489375" indent="0">
              <a:buNone/>
              <a:defRPr sz="1303" b="1"/>
            </a:lvl5pPr>
            <a:lvl6pPr marL="1861718" indent="0">
              <a:buNone/>
              <a:defRPr sz="1303" b="1"/>
            </a:lvl6pPr>
            <a:lvl7pPr marL="2234062" indent="0">
              <a:buNone/>
              <a:defRPr sz="1303" b="1"/>
            </a:lvl7pPr>
            <a:lvl8pPr marL="2606406" indent="0">
              <a:buNone/>
              <a:defRPr sz="1303" b="1"/>
            </a:lvl8pPr>
            <a:lvl9pPr marL="2978749" indent="0">
              <a:buNone/>
              <a:defRPr sz="130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294591" y="2040012"/>
            <a:ext cx="4446203" cy="300055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48809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99661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48138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0381" y="372322"/>
            <a:ext cx="3373122" cy="1303126"/>
          </a:xfrm>
        </p:spPr>
        <p:txBody>
          <a:bodyPr anchor="b"/>
          <a:lstStyle>
            <a:lvl1pPr>
              <a:defRPr sz="260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446204" y="804112"/>
            <a:ext cx="5294590" cy="3968846"/>
          </a:xfrm>
        </p:spPr>
        <p:txBody>
          <a:bodyPr/>
          <a:lstStyle>
            <a:lvl1pPr>
              <a:defRPr sz="2606"/>
            </a:lvl1pPr>
            <a:lvl2pPr>
              <a:defRPr sz="2280"/>
            </a:lvl2pPr>
            <a:lvl3pPr>
              <a:defRPr sz="1955"/>
            </a:lvl3pPr>
            <a:lvl4pPr>
              <a:defRPr sz="1629"/>
            </a:lvl4pPr>
            <a:lvl5pPr>
              <a:defRPr sz="1629"/>
            </a:lvl5pPr>
            <a:lvl6pPr>
              <a:defRPr sz="1629"/>
            </a:lvl6pPr>
            <a:lvl7pPr>
              <a:defRPr sz="1629"/>
            </a:lvl7pPr>
            <a:lvl8pPr>
              <a:defRPr sz="1629"/>
            </a:lvl8pPr>
            <a:lvl9pPr>
              <a:defRPr sz="162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20381" y="1675447"/>
            <a:ext cx="3373122" cy="3103974"/>
          </a:xfrm>
        </p:spPr>
        <p:txBody>
          <a:bodyPr/>
          <a:lstStyle>
            <a:lvl1pPr marL="0" indent="0">
              <a:buNone/>
              <a:defRPr sz="1303"/>
            </a:lvl1pPr>
            <a:lvl2pPr marL="372344" indent="0">
              <a:buNone/>
              <a:defRPr sz="1140"/>
            </a:lvl2pPr>
            <a:lvl3pPr marL="744687" indent="0">
              <a:buNone/>
              <a:defRPr sz="977"/>
            </a:lvl3pPr>
            <a:lvl4pPr marL="1117031" indent="0">
              <a:buNone/>
              <a:defRPr sz="814"/>
            </a:lvl4pPr>
            <a:lvl5pPr marL="1489375" indent="0">
              <a:buNone/>
              <a:defRPr sz="814"/>
            </a:lvl5pPr>
            <a:lvl6pPr marL="1861718" indent="0">
              <a:buNone/>
              <a:defRPr sz="814"/>
            </a:lvl6pPr>
            <a:lvl7pPr marL="2234062" indent="0">
              <a:buNone/>
              <a:defRPr sz="814"/>
            </a:lvl7pPr>
            <a:lvl8pPr marL="2606406" indent="0">
              <a:buNone/>
              <a:defRPr sz="814"/>
            </a:lvl8pPr>
            <a:lvl9pPr marL="2978749" indent="0">
              <a:buNone/>
              <a:defRPr sz="81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37124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0381" y="372322"/>
            <a:ext cx="3373122" cy="1303126"/>
          </a:xfrm>
        </p:spPr>
        <p:txBody>
          <a:bodyPr anchor="b"/>
          <a:lstStyle>
            <a:lvl1pPr>
              <a:defRPr sz="260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446204" y="804112"/>
            <a:ext cx="5294590" cy="3968846"/>
          </a:xfrm>
        </p:spPr>
        <p:txBody>
          <a:bodyPr anchor="t"/>
          <a:lstStyle>
            <a:lvl1pPr marL="0" indent="0">
              <a:buNone/>
              <a:defRPr sz="2606"/>
            </a:lvl1pPr>
            <a:lvl2pPr marL="372344" indent="0">
              <a:buNone/>
              <a:defRPr sz="2280"/>
            </a:lvl2pPr>
            <a:lvl3pPr marL="744687" indent="0">
              <a:buNone/>
              <a:defRPr sz="1955"/>
            </a:lvl3pPr>
            <a:lvl4pPr marL="1117031" indent="0">
              <a:buNone/>
              <a:defRPr sz="1629"/>
            </a:lvl4pPr>
            <a:lvl5pPr marL="1489375" indent="0">
              <a:buNone/>
              <a:defRPr sz="1629"/>
            </a:lvl5pPr>
            <a:lvl6pPr marL="1861718" indent="0">
              <a:buNone/>
              <a:defRPr sz="1629"/>
            </a:lvl6pPr>
            <a:lvl7pPr marL="2234062" indent="0">
              <a:buNone/>
              <a:defRPr sz="1629"/>
            </a:lvl7pPr>
            <a:lvl8pPr marL="2606406" indent="0">
              <a:buNone/>
              <a:defRPr sz="1629"/>
            </a:lvl8pPr>
            <a:lvl9pPr marL="2978749" indent="0">
              <a:buNone/>
              <a:defRPr sz="162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20381" y="1675447"/>
            <a:ext cx="3373122" cy="3103974"/>
          </a:xfrm>
        </p:spPr>
        <p:txBody>
          <a:bodyPr/>
          <a:lstStyle>
            <a:lvl1pPr marL="0" indent="0">
              <a:buNone/>
              <a:defRPr sz="1303"/>
            </a:lvl1pPr>
            <a:lvl2pPr marL="372344" indent="0">
              <a:buNone/>
              <a:defRPr sz="1140"/>
            </a:lvl2pPr>
            <a:lvl3pPr marL="744687" indent="0">
              <a:buNone/>
              <a:defRPr sz="977"/>
            </a:lvl3pPr>
            <a:lvl4pPr marL="1117031" indent="0">
              <a:buNone/>
              <a:defRPr sz="814"/>
            </a:lvl4pPr>
            <a:lvl5pPr marL="1489375" indent="0">
              <a:buNone/>
              <a:defRPr sz="814"/>
            </a:lvl5pPr>
            <a:lvl6pPr marL="1861718" indent="0">
              <a:buNone/>
              <a:defRPr sz="814"/>
            </a:lvl6pPr>
            <a:lvl7pPr marL="2234062" indent="0">
              <a:buNone/>
              <a:defRPr sz="814"/>
            </a:lvl7pPr>
            <a:lvl8pPr marL="2606406" indent="0">
              <a:buNone/>
              <a:defRPr sz="814"/>
            </a:lvl8pPr>
            <a:lvl9pPr marL="2978749" indent="0">
              <a:buNone/>
              <a:defRPr sz="81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79607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19019" y="297340"/>
            <a:ext cx="9020413" cy="10794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19019" y="1486701"/>
            <a:ext cx="9020413" cy="354352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19019" y="5176306"/>
            <a:ext cx="2353151" cy="2973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7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FF4FED-4C57-430B-835A-43F3BDFC4229}" type="datetimeFigureOut">
              <a:rPr lang="en-GB" smtClean="0"/>
              <a:t>18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464362" y="5176306"/>
            <a:ext cx="3529727" cy="2973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7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386280" y="5176306"/>
            <a:ext cx="2353151" cy="2973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7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78E1B5-B271-4A0C-B79D-E09A18CA39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28799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5" r:id="rId1"/>
    <p:sldLayoutId id="2147483746" r:id="rId2"/>
    <p:sldLayoutId id="2147483747" r:id="rId3"/>
    <p:sldLayoutId id="2147483748" r:id="rId4"/>
    <p:sldLayoutId id="2147483749" r:id="rId5"/>
    <p:sldLayoutId id="2147483750" r:id="rId6"/>
    <p:sldLayoutId id="2147483751" r:id="rId7"/>
    <p:sldLayoutId id="2147483752" r:id="rId8"/>
    <p:sldLayoutId id="2147483753" r:id="rId9"/>
    <p:sldLayoutId id="2147483754" r:id="rId10"/>
    <p:sldLayoutId id="2147483755" r:id="rId11"/>
  </p:sldLayoutIdLst>
  <p:txStyles>
    <p:titleStyle>
      <a:lvl1pPr algn="l" defTabSz="744687" rtl="0" eaLnBrk="1" latinLnBrk="0" hangingPunct="1">
        <a:lnSpc>
          <a:spcPct val="90000"/>
        </a:lnSpc>
        <a:spcBef>
          <a:spcPct val="0"/>
        </a:spcBef>
        <a:buNone/>
        <a:defRPr sz="358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6172" indent="-186172" algn="l" defTabSz="744687" rtl="0" eaLnBrk="1" latinLnBrk="0" hangingPunct="1">
        <a:lnSpc>
          <a:spcPct val="90000"/>
        </a:lnSpc>
        <a:spcBef>
          <a:spcPts val="814"/>
        </a:spcBef>
        <a:buFont typeface="Arial" panose="020B0604020202020204" pitchFamily="34" charset="0"/>
        <a:buChar char="•"/>
        <a:defRPr sz="2280" kern="1200">
          <a:solidFill>
            <a:schemeClr val="tx1"/>
          </a:solidFill>
          <a:latin typeface="+mn-lt"/>
          <a:ea typeface="+mn-ea"/>
          <a:cs typeface="+mn-cs"/>
        </a:defRPr>
      </a:lvl1pPr>
      <a:lvl2pPr marL="558516" indent="-186172" algn="l" defTabSz="744687" rtl="0" eaLnBrk="1" latinLnBrk="0" hangingPunct="1">
        <a:lnSpc>
          <a:spcPct val="90000"/>
        </a:lnSpc>
        <a:spcBef>
          <a:spcPts val="407"/>
        </a:spcBef>
        <a:buFont typeface="Arial" panose="020B0604020202020204" pitchFamily="34" charset="0"/>
        <a:buChar char="•"/>
        <a:defRPr sz="1955" kern="1200">
          <a:solidFill>
            <a:schemeClr val="tx1"/>
          </a:solidFill>
          <a:latin typeface="+mn-lt"/>
          <a:ea typeface="+mn-ea"/>
          <a:cs typeface="+mn-cs"/>
        </a:defRPr>
      </a:lvl2pPr>
      <a:lvl3pPr marL="930859" indent="-186172" algn="l" defTabSz="744687" rtl="0" eaLnBrk="1" latinLnBrk="0" hangingPunct="1">
        <a:lnSpc>
          <a:spcPct val="90000"/>
        </a:lnSpc>
        <a:spcBef>
          <a:spcPts val="407"/>
        </a:spcBef>
        <a:buFont typeface="Arial" panose="020B0604020202020204" pitchFamily="34" charset="0"/>
        <a:buChar char="•"/>
        <a:defRPr sz="1629" kern="1200">
          <a:solidFill>
            <a:schemeClr val="tx1"/>
          </a:solidFill>
          <a:latin typeface="+mn-lt"/>
          <a:ea typeface="+mn-ea"/>
          <a:cs typeface="+mn-cs"/>
        </a:defRPr>
      </a:lvl3pPr>
      <a:lvl4pPr marL="1303203" indent="-186172" algn="l" defTabSz="744687" rtl="0" eaLnBrk="1" latinLnBrk="0" hangingPunct="1">
        <a:lnSpc>
          <a:spcPct val="90000"/>
        </a:lnSpc>
        <a:spcBef>
          <a:spcPts val="407"/>
        </a:spcBef>
        <a:buFont typeface="Arial" panose="020B0604020202020204" pitchFamily="34" charset="0"/>
        <a:buChar char="•"/>
        <a:defRPr sz="1466" kern="1200">
          <a:solidFill>
            <a:schemeClr val="tx1"/>
          </a:solidFill>
          <a:latin typeface="+mn-lt"/>
          <a:ea typeface="+mn-ea"/>
          <a:cs typeface="+mn-cs"/>
        </a:defRPr>
      </a:lvl4pPr>
      <a:lvl5pPr marL="1675547" indent="-186172" algn="l" defTabSz="744687" rtl="0" eaLnBrk="1" latinLnBrk="0" hangingPunct="1">
        <a:lnSpc>
          <a:spcPct val="90000"/>
        </a:lnSpc>
        <a:spcBef>
          <a:spcPts val="407"/>
        </a:spcBef>
        <a:buFont typeface="Arial" panose="020B0604020202020204" pitchFamily="34" charset="0"/>
        <a:buChar char="•"/>
        <a:defRPr sz="1466" kern="1200">
          <a:solidFill>
            <a:schemeClr val="tx1"/>
          </a:solidFill>
          <a:latin typeface="+mn-lt"/>
          <a:ea typeface="+mn-ea"/>
          <a:cs typeface="+mn-cs"/>
        </a:defRPr>
      </a:lvl5pPr>
      <a:lvl6pPr marL="2047890" indent="-186172" algn="l" defTabSz="744687" rtl="0" eaLnBrk="1" latinLnBrk="0" hangingPunct="1">
        <a:lnSpc>
          <a:spcPct val="90000"/>
        </a:lnSpc>
        <a:spcBef>
          <a:spcPts val="407"/>
        </a:spcBef>
        <a:buFont typeface="Arial" panose="020B0604020202020204" pitchFamily="34" charset="0"/>
        <a:buChar char="•"/>
        <a:defRPr sz="1466" kern="1200">
          <a:solidFill>
            <a:schemeClr val="tx1"/>
          </a:solidFill>
          <a:latin typeface="+mn-lt"/>
          <a:ea typeface="+mn-ea"/>
          <a:cs typeface="+mn-cs"/>
        </a:defRPr>
      </a:lvl6pPr>
      <a:lvl7pPr marL="2420234" indent="-186172" algn="l" defTabSz="744687" rtl="0" eaLnBrk="1" latinLnBrk="0" hangingPunct="1">
        <a:lnSpc>
          <a:spcPct val="90000"/>
        </a:lnSpc>
        <a:spcBef>
          <a:spcPts val="407"/>
        </a:spcBef>
        <a:buFont typeface="Arial" panose="020B0604020202020204" pitchFamily="34" charset="0"/>
        <a:buChar char="•"/>
        <a:defRPr sz="1466" kern="1200">
          <a:solidFill>
            <a:schemeClr val="tx1"/>
          </a:solidFill>
          <a:latin typeface="+mn-lt"/>
          <a:ea typeface="+mn-ea"/>
          <a:cs typeface="+mn-cs"/>
        </a:defRPr>
      </a:lvl7pPr>
      <a:lvl8pPr marL="2792578" indent="-186172" algn="l" defTabSz="744687" rtl="0" eaLnBrk="1" latinLnBrk="0" hangingPunct="1">
        <a:lnSpc>
          <a:spcPct val="90000"/>
        </a:lnSpc>
        <a:spcBef>
          <a:spcPts val="407"/>
        </a:spcBef>
        <a:buFont typeface="Arial" panose="020B0604020202020204" pitchFamily="34" charset="0"/>
        <a:buChar char="•"/>
        <a:defRPr sz="1466" kern="1200">
          <a:solidFill>
            <a:schemeClr val="tx1"/>
          </a:solidFill>
          <a:latin typeface="+mn-lt"/>
          <a:ea typeface="+mn-ea"/>
          <a:cs typeface="+mn-cs"/>
        </a:defRPr>
      </a:lvl8pPr>
      <a:lvl9pPr marL="3164921" indent="-186172" algn="l" defTabSz="744687" rtl="0" eaLnBrk="1" latinLnBrk="0" hangingPunct="1">
        <a:lnSpc>
          <a:spcPct val="90000"/>
        </a:lnSpc>
        <a:spcBef>
          <a:spcPts val="407"/>
        </a:spcBef>
        <a:buFont typeface="Arial" panose="020B0604020202020204" pitchFamily="34" charset="0"/>
        <a:buChar char="•"/>
        <a:defRPr sz="146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44687" rtl="0" eaLnBrk="1" latinLnBrk="0" hangingPunct="1">
        <a:defRPr sz="1466" kern="1200">
          <a:solidFill>
            <a:schemeClr val="tx1"/>
          </a:solidFill>
          <a:latin typeface="+mn-lt"/>
          <a:ea typeface="+mn-ea"/>
          <a:cs typeface="+mn-cs"/>
        </a:defRPr>
      </a:lvl1pPr>
      <a:lvl2pPr marL="372344" algn="l" defTabSz="744687" rtl="0" eaLnBrk="1" latinLnBrk="0" hangingPunct="1">
        <a:defRPr sz="1466" kern="1200">
          <a:solidFill>
            <a:schemeClr val="tx1"/>
          </a:solidFill>
          <a:latin typeface="+mn-lt"/>
          <a:ea typeface="+mn-ea"/>
          <a:cs typeface="+mn-cs"/>
        </a:defRPr>
      </a:lvl2pPr>
      <a:lvl3pPr marL="744687" algn="l" defTabSz="744687" rtl="0" eaLnBrk="1" latinLnBrk="0" hangingPunct="1">
        <a:defRPr sz="1466" kern="1200">
          <a:solidFill>
            <a:schemeClr val="tx1"/>
          </a:solidFill>
          <a:latin typeface="+mn-lt"/>
          <a:ea typeface="+mn-ea"/>
          <a:cs typeface="+mn-cs"/>
        </a:defRPr>
      </a:lvl3pPr>
      <a:lvl4pPr marL="1117031" algn="l" defTabSz="744687" rtl="0" eaLnBrk="1" latinLnBrk="0" hangingPunct="1">
        <a:defRPr sz="1466" kern="1200">
          <a:solidFill>
            <a:schemeClr val="tx1"/>
          </a:solidFill>
          <a:latin typeface="+mn-lt"/>
          <a:ea typeface="+mn-ea"/>
          <a:cs typeface="+mn-cs"/>
        </a:defRPr>
      </a:lvl4pPr>
      <a:lvl5pPr marL="1489375" algn="l" defTabSz="744687" rtl="0" eaLnBrk="1" latinLnBrk="0" hangingPunct="1">
        <a:defRPr sz="1466" kern="1200">
          <a:solidFill>
            <a:schemeClr val="tx1"/>
          </a:solidFill>
          <a:latin typeface="+mn-lt"/>
          <a:ea typeface="+mn-ea"/>
          <a:cs typeface="+mn-cs"/>
        </a:defRPr>
      </a:lvl5pPr>
      <a:lvl6pPr marL="1861718" algn="l" defTabSz="744687" rtl="0" eaLnBrk="1" latinLnBrk="0" hangingPunct="1">
        <a:defRPr sz="1466" kern="1200">
          <a:solidFill>
            <a:schemeClr val="tx1"/>
          </a:solidFill>
          <a:latin typeface="+mn-lt"/>
          <a:ea typeface="+mn-ea"/>
          <a:cs typeface="+mn-cs"/>
        </a:defRPr>
      </a:lvl6pPr>
      <a:lvl7pPr marL="2234062" algn="l" defTabSz="744687" rtl="0" eaLnBrk="1" latinLnBrk="0" hangingPunct="1">
        <a:defRPr sz="1466" kern="1200">
          <a:solidFill>
            <a:schemeClr val="tx1"/>
          </a:solidFill>
          <a:latin typeface="+mn-lt"/>
          <a:ea typeface="+mn-ea"/>
          <a:cs typeface="+mn-cs"/>
        </a:defRPr>
      </a:lvl7pPr>
      <a:lvl8pPr marL="2606406" algn="l" defTabSz="744687" rtl="0" eaLnBrk="1" latinLnBrk="0" hangingPunct="1">
        <a:defRPr sz="1466" kern="1200">
          <a:solidFill>
            <a:schemeClr val="tx1"/>
          </a:solidFill>
          <a:latin typeface="+mn-lt"/>
          <a:ea typeface="+mn-ea"/>
          <a:cs typeface="+mn-cs"/>
        </a:defRPr>
      </a:lvl8pPr>
      <a:lvl9pPr marL="2978749" algn="l" defTabSz="744687" rtl="0" eaLnBrk="1" latinLnBrk="0" hangingPunct="1">
        <a:defRPr sz="146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58361" y="867772"/>
            <a:ext cx="9977948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GB" sz="10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nline Resource 7. </a:t>
            </a:r>
            <a:r>
              <a:rPr lang="en-GB" sz="10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inical fractures after stopping </a:t>
            </a:r>
            <a:r>
              <a:rPr lang="en-GB" sz="1000" kern="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riparatide</a:t>
            </a:r>
            <a:r>
              <a:rPr lang="en-GB" sz="10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reatment (Post-Treatment Follow-Up Cohort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58361" y="4957058"/>
            <a:ext cx="9977948" cy="50783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GB" sz="9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rom logistic regression model with repeated measures analysis (model adjusted for gender, age, prior bisphosphonate use, and a history of vertebral or non-vertebral fracture in the last 12 months before starting </a:t>
            </a:r>
            <a:r>
              <a:rPr lang="en-GB" sz="900" kern="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riparatide</a:t>
            </a:r>
            <a:r>
              <a:rPr lang="en-GB" sz="9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>
              <a:defRPr/>
            </a:pPr>
            <a:r>
              <a:rPr lang="en-GB" sz="900" i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/A</a:t>
            </a:r>
            <a:r>
              <a:rPr lang="en-GB" sz="9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ata not available as the numbers were too small for useful results</a:t>
            </a: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77660446"/>
              </p:ext>
            </p:extLst>
          </p:nvPr>
        </p:nvGraphicFramePr>
        <p:xfrm>
          <a:off x="223325" y="1179927"/>
          <a:ext cx="9977948" cy="3755009"/>
        </p:xfrm>
        <a:graphic>
          <a:graphicData uri="http://schemas.openxmlformats.org/drawingml/2006/table">
            <a:tbl>
              <a:tblPr firstRow="1" firstCol="1" bandRow="1"/>
              <a:tblGrid>
                <a:gridCol w="2114294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056934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327759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776614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1039660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1465546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1552823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644318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</a:tblGrid>
              <a:tr h="198719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ype of fracture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 number of patients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umber (%) of patients with ≥1 fracture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umber of fractures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Odds of fracture 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95% CI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Odds ratio of fracture (95% CI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1" i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</a:t>
                      </a:r>
                      <a:r>
                        <a:rPr lang="en-GB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value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357869">
                <a:tc>
                  <a:txBody>
                    <a:bodyPr/>
                    <a:lstStyle/>
                    <a:p>
                      <a:pPr marL="113665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ime interval after stopping teriparatide treatment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er given interval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er 10,000 patient-years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98719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ny clinical fracture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198719">
                <a:tc>
                  <a:txBody>
                    <a:bodyPr/>
                    <a:lstStyle/>
                    <a:p>
                      <a:pPr marL="113665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0 to 6 months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07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3 (1.8)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5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22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013 (0.006, 0.025)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198719">
                <a:tc>
                  <a:txBody>
                    <a:bodyPr/>
                    <a:lstStyle/>
                    <a:p>
                      <a:pPr marL="113665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6 to 12 months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09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6 (1.4)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6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05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011 (0.005, 0.021)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84 (0.44, 1.61)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594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198719">
                <a:tc>
                  <a:txBody>
                    <a:bodyPr/>
                    <a:lstStyle/>
                    <a:p>
                      <a:pPr marL="113665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12 to 18 months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94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7 (1.7)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1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66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013 (0.007, 0.024)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01 0.53, 1.92)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975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198719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linical vertebral fracture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198719">
                <a:tc>
                  <a:txBody>
                    <a:bodyPr/>
                    <a:lstStyle/>
                    <a:p>
                      <a:pPr marL="113665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0 to 6 months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07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 (0.2)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8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198719">
                <a:tc>
                  <a:txBody>
                    <a:bodyPr/>
                    <a:lstStyle/>
                    <a:p>
                      <a:pPr marL="113665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6 to 12 months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09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 (0.2)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8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/A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/A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/A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198719">
                <a:tc>
                  <a:txBody>
                    <a:bodyPr/>
                    <a:lstStyle/>
                    <a:p>
                      <a:pPr marL="113665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12 to 18 months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94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 (0.2)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4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198719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on-vertebral fracture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198719">
                <a:tc>
                  <a:txBody>
                    <a:bodyPr/>
                    <a:lstStyle/>
                    <a:p>
                      <a:pPr marL="113665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0 to 6 months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07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0 (1.5)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1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55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013 (0.006, 0.025)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198719">
                <a:tc>
                  <a:txBody>
                    <a:bodyPr/>
                    <a:lstStyle/>
                    <a:p>
                      <a:pPr marL="113665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6 to 12 months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09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 (1.3)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67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011 (0.005, 0.021)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84 (0.42, 1.68)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623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198719">
                <a:tc>
                  <a:txBody>
                    <a:bodyPr/>
                    <a:lstStyle/>
                    <a:p>
                      <a:pPr marL="113665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12 to 18 months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94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5 (1.5)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9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22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013 (0.007, 0.024)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02 (0.52, 2.02)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954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  <a:tr h="217636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ain non-vertebral fracture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4"/>
                  </a:ext>
                </a:extLst>
              </a:tr>
              <a:tr h="198719">
                <a:tc>
                  <a:txBody>
                    <a:bodyPr/>
                    <a:lstStyle/>
                    <a:p>
                      <a:pPr marL="113665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0 to 6 months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07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8 (1.4)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8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04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012 (0.006, 0.025)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5"/>
                  </a:ext>
                </a:extLst>
              </a:tr>
              <a:tr h="198719">
                <a:tc>
                  <a:txBody>
                    <a:bodyPr/>
                    <a:lstStyle/>
                    <a:p>
                      <a:pPr marL="113665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6 to 12 months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09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 (1.3)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67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011 (0.006, 0.023)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94 (0.46, 1.90)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855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6"/>
                  </a:ext>
                </a:extLst>
              </a:tr>
              <a:tr h="198719">
                <a:tc>
                  <a:txBody>
                    <a:bodyPr/>
                    <a:lstStyle/>
                    <a:p>
                      <a:pPr marL="113665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gt;12 to 18 months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94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 (1.1)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5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33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010 (0.005, 0.020)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83 (0.39, 1.78)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633</a:t>
                      </a:r>
                    </a:p>
                  </a:txBody>
                  <a:tcPr marL="64247" marR="642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7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6C06A427-B3E5-4086-A065-5D2E6DA12D70}"/>
              </a:ext>
            </a:extLst>
          </p:cNvPr>
          <p:cNvSpPr txBox="1"/>
          <p:nvPr/>
        </p:nvSpPr>
        <p:spPr>
          <a:xfrm>
            <a:off x="158361" y="145396"/>
            <a:ext cx="9977948" cy="707886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Effectiveness of teriparatide in patients with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osteoporosis in clinical practice: 42-month results during and after discontinuation of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treatment from the European Extended </a:t>
            </a:r>
            <a:r>
              <a:rPr lang="en-GB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Forsteo</a:t>
            </a:r>
            <a:r>
              <a:rPr lang="en-GB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®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Observational Study (</a:t>
            </a:r>
            <a:r>
              <a:rPr lang="en-GB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ExFOS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Calcified Tissue International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. Napoli, B. L.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Langdahl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, Ö.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Ljunggren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, E.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Lespessaille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, G.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Kapetanos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, T.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Kocjan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, T. Nikolic, P.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Eiken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, H.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Petto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, T. Moll, E. Lindh, F. Marin</a:t>
            </a:r>
          </a:p>
          <a:p>
            <a:pPr>
              <a:defRPr/>
            </a:pPr>
            <a:r>
              <a:rPr lang="en-GB" sz="8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rresponding author: Nicola Napoli,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University Campus Bio-Medico, Rome, Italy; e-mail: </a:t>
            </a:r>
            <a:r>
              <a:rPr lang="en-GB" sz="8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.Napoli@unicampus.it</a:t>
            </a:r>
          </a:p>
        </p:txBody>
      </p:sp>
    </p:spTree>
    <p:extLst>
      <p:ext uri="{BB962C8B-B14F-4D97-AF65-F5344CB8AC3E}">
        <p14:creationId xmlns:p14="http://schemas.microsoft.com/office/powerpoint/2010/main" val="3635287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</TotalTime>
  <Words>472</Words>
  <Application>Microsoft Office PowerPoint</Application>
  <PresentationFormat>Custom</PresentationFormat>
  <Paragraphs>14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x</dc:creator>
  <cp:lastModifiedBy>Rx</cp:lastModifiedBy>
  <cp:revision>13</cp:revision>
  <dcterms:created xsi:type="dcterms:W3CDTF">2017-07-05T13:17:28Z</dcterms:created>
  <dcterms:modified xsi:type="dcterms:W3CDTF">2018-01-18T14:01:11Z</dcterms:modified>
</cp:coreProperties>
</file>